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21" y="19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1096F2-CAF2-5B26-F9F7-6151351D3A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2287A9B-CD6F-75F3-847D-57127C89A5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F73FEF-2767-935F-EAB3-2D567CEDA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332FB5-405E-AC5F-0C27-589C383B6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A8E1733-FEAC-3DEA-601B-009D2D3B81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1861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A420FF-A87A-F977-54F0-D90EA3F48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91409B-D9C4-9746-B2F3-8B56C57377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3AD37F-C502-D82D-ECD2-EC80CEC4D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2FD3273-690F-DC05-493D-8C9DD43BC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BCF5998-1DE7-C37E-A31A-D855F9BE1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6001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C74BE63-D6FE-EBFF-9090-85BB5A0CFA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826919F-94AD-4CBB-C40C-F1C7383482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E72C05-F5F8-264D-D0AB-C68515015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1221D7-5B62-4FC4-7AA1-DC091442F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93C4B3-2A8D-6F1F-D482-4ACFD7B85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60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046C66-DB53-12D4-2096-474D778D9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D94B67-198E-3471-F302-63983A531D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53F37-DAC9-67B8-457B-540606E4A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DE51EC1-15F5-119A-65CE-71CD7EF0B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CE2AAF-3021-3545-8B7C-4A604D3CC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3129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ABF7F2-6461-8F47-1B8E-75023A8322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682E8F2-C581-CD7A-12DA-0FA0ACB5CE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00990B-9100-3468-D70E-D6400C87F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856CBA-E60A-9A52-37F6-D42952EB27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F61BA7-276C-DDE4-774A-0981CD6A1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6355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FA2881-F959-DBB9-DBA3-5F1F8BF80C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1A7F8C1-D043-695C-AF19-4D032F9679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AEB2ABB-68AE-FAC9-041B-60CF0DF99E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9F9C894-4514-22C2-687E-AEB8B6BB8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95D6CA3-F304-C872-4A9F-DC2E1EA1C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9E21AB-F543-FDF9-C6EC-503601204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19765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02F650-CC5C-5F11-B4CD-DDAA4775A3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CCAB51-2BE2-BD4C-1849-35118A97C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979F17D-02EC-2C8C-683B-5205C965B7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ADE27EC-E63E-639E-4A85-0367DE0C71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90CE192-B874-F271-879F-6AA0974BC1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A6DD6C7-5F88-A41D-C76D-798FDBFB4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C1915FA-0F4A-4FB8-22CF-49DC7F14C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3425ACD-6D71-423E-7A40-B83FEF386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1780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6891BF-A40C-06D4-0516-2788AC85A7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F1573D4-320D-4981-99C7-EE9C6B525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C12BDC7-C38B-7E7D-D048-A418868714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CAD6880-079F-EBF2-4337-7600652A25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837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43E3931-9BFC-64FA-BBB5-16449F427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79C555F-E2E9-ADBF-FB61-28CA0F286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0696AEF-E674-29B3-412B-24A1BCC41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7041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93A71C-E40F-64A0-6DC3-B2109DBE5E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EF94E57-8EF6-70FE-C35C-96C96A3177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EBA73C-6B53-16E3-FAA1-3B4F1194FB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402DA2D-7706-1664-06C6-39C6D8B80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0FCAE53-423C-34B3-CBF1-88CBD7781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4BE8D49-BEBD-2D02-C3AE-7E8C5D1B9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5714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6C8E16-64D4-905C-CDA4-683F3D64EC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90FC7C6-CAFD-A8B0-415A-FE198812EF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E14E5C5-C1EA-0B6F-2BAC-CFC19472D5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F743B40-F814-C915-9EAD-0511131D8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FCD4F78-AF9C-AF03-3657-FD5845398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098965E-A60D-1FB0-8725-CD400066F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4790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0161785-A3EF-D45B-57B2-810F44A08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F4D421-A467-D6CF-6B7C-A97D4237D4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463A70-C315-ACB2-585A-4C89FDD94D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3E8E8-425A-43F4-97A5-033B6C2D9A8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04862DD-69B3-6D7C-9EF1-41E5D285D1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0D6493-98E2-095F-9C61-0E03061036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FEC6D-3387-4673-A11F-27232FAFEA7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1821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D4B86B-50EB-2F25-0369-A494F9DB5C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S1. Risk of bias assessment.</a:t>
            </a:r>
            <a:r>
              <a:rPr lang="en-US" altLang="zh-CN" sz="1800">
                <a:effectLst/>
                <a:latin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</a:t>
            </a:r>
            <a:r>
              <a:rPr lang="en-US" altLang="zh-CN" sz="1800">
                <a:effectLst/>
                <a:latin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Risk of bias graph. B. Risk of bias summary</a:t>
            </a:r>
            <a:endParaRPr lang="zh-CN" altLang="en-US"/>
          </a:p>
        </p:txBody>
      </p:sp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D5649323-41C3-FB94-802F-F0FCD58F5E28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>
          <a:blip r:embed="rId2"/>
          <a:stretch>
            <a:fillRect/>
          </a:stretch>
        </p:blipFill>
        <p:spPr>
          <a:xfrm>
            <a:off x="838200" y="1825625"/>
            <a:ext cx="5181600" cy="2222476"/>
          </a:xfrm>
          <a:prstGeom prst="rect">
            <a:avLst/>
          </a:prstGeom>
        </p:spPr>
      </p:pic>
      <p:pic>
        <p:nvPicPr>
          <p:cNvPr id="6" name="内容占位符 5">
            <a:extLst>
              <a:ext uri="{FF2B5EF4-FFF2-40B4-BE49-F238E27FC236}">
                <a16:creationId xmlns:a16="http://schemas.microsoft.com/office/drawing/2014/main" id="{090FBF24-5C5E-E631-1DAE-5F0D5D9C7B00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7088918" y="1690688"/>
            <a:ext cx="3412900" cy="435133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41896A9D-67CE-B1EB-52BD-9873B62BBE39}"/>
              </a:ext>
            </a:extLst>
          </p:cNvPr>
          <p:cNvSpPr txBox="1"/>
          <p:nvPr/>
        </p:nvSpPr>
        <p:spPr>
          <a:xfrm>
            <a:off x="1781787" y="4611039"/>
            <a:ext cx="6097348" cy="3912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altLang="zh-CN" sz="18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. Risk of bias graph</a:t>
            </a:r>
            <a:endParaRPr lang="zh-CN" altLang="zh-CN" sz="2400" kern="10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C9DC60B-2D2C-C665-4C81-C8D4A77AF039}"/>
              </a:ext>
            </a:extLst>
          </p:cNvPr>
          <p:cNvSpPr txBox="1"/>
          <p:nvPr/>
        </p:nvSpPr>
        <p:spPr>
          <a:xfrm>
            <a:off x="6657721" y="5974997"/>
            <a:ext cx="6097348" cy="3912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914400" algn="just">
              <a:lnSpc>
                <a:spcPct val="115000"/>
              </a:lnSpc>
            </a:pPr>
            <a:r>
              <a:rPr lang="en-US" altLang="zh-CN" sz="18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. Risk of bias summary</a:t>
            </a:r>
            <a:endParaRPr lang="zh-CN" altLang="zh-CN" sz="2400" kern="10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213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Supplementary figure S1. Risk of bias assessment. A. Risk of bias graph. B. Risk of bias summar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万乾 余</dc:creator>
  <cp:lastModifiedBy>万乾 余</cp:lastModifiedBy>
  <cp:revision>1</cp:revision>
  <dcterms:created xsi:type="dcterms:W3CDTF">2025-01-03T17:43:26Z</dcterms:created>
  <dcterms:modified xsi:type="dcterms:W3CDTF">2025-01-03T17:44:31Z</dcterms:modified>
</cp:coreProperties>
</file>